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90" d="100"/>
          <a:sy n="90" d="100"/>
        </p:scale>
        <p:origin x="-816" y="-72"/>
      </p:cViewPr>
      <p:guideLst>
        <p:guide orient="horz" pos="2296"/>
        <p:guide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23B8C-A741-4FC4-BCAA-AA64C1FC1F6E}" type="datetimeFigureOut">
              <a:rPr lang="sv-SE" smtClean="0"/>
              <a:t>2021-08-13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774AB-FCF0-4D1B-8EE5-6BEDA43C83B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552899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23B8C-A741-4FC4-BCAA-AA64C1FC1F6E}" type="datetimeFigureOut">
              <a:rPr lang="sv-SE" smtClean="0"/>
              <a:t>2021-08-13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774AB-FCF0-4D1B-8EE5-6BEDA43C83B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45131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23B8C-A741-4FC4-BCAA-AA64C1FC1F6E}" type="datetimeFigureOut">
              <a:rPr lang="sv-SE" smtClean="0"/>
              <a:t>2021-08-13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774AB-FCF0-4D1B-8EE5-6BEDA43C83B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7223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23B8C-A741-4FC4-BCAA-AA64C1FC1F6E}" type="datetimeFigureOut">
              <a:rPr lang="sv-SE" smtClean="0"/>
              <a:t>2021-08-13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774AB-FCF0-4D1B-8EE5-6BEDA43C83B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45381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23B8C-A741-4FC4-BCAA-AA64C1FC1F6E}" type="datetimeFigureOut">
              <a:rPr lang="sv-SE" smtClean="0"/>
              <a:t>2021-08-13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774AB-FCF0-4D1B-8EE5-6BEDA43C83B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755619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23B8C-A741-4FC4-BCAA-AA64C1FC1F6E}" type="datetimeFigureOut">
              <a:rPr lang="sv-SE" smtClean="0"/>
              <a:t>2021-08-13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774AB-FCF0-4D1B-8EE5-6BEDA43C83B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931845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23B8C-A741-4FC4-BCAA-AA64C1FC1F6E}" type="datetimeFigureOut">
              <a:rPr lang="sv-SE" smtClean="0"/>
              <a:t>2021-08-13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774AB-FCF0-4D1B-8EE5-6BEDA43C83B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32708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23B8C-A741-4FC4-BCAA-AA64C1FC1F6E}" type="datetimeFigureOut">
              <a:rPr lang="sv-SE" smtClean="0"/>
              <a:t>2021-08-13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774AB-FCF0-4D1B-8EE5-6BEDA43C83B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953464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23B8C-A741-4FC4-BCAA-AA64C1FC1F6E}" type="datetimeFigureOut">
              <a:rPr lang="sv-SE" smtClean="0"/>
              <a:t>2021-08-13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774AB-FCF0-4D1B-8EE5-6BEDA43C83B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75412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23B8C-A741-4FC4-BCAA-AA64C1FC1F6E}" type="datetimeFigureOut">
              <a:rPr lang="sv-SE" smtClean="0"/>
              <a:t>2021-08-13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774AB-FCF0-4D1B-8EE5-6BEDA43C83B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23850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23B8C-A741-4FC4-BCAA-AA64C1FC1F6E}" type="datetimeFigureOut">
              <a:rPr lang="sv-SE" smtClean="0"/>
              <a:t>2021-08-13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774AB-FCF0-4D1B-8EE5-6BEDA43C83B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57524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B23B8C-A741-4FC4-BCAA-AA64C1FC1F6E}" type="datetimeFigureOut">
              <a:rPr lang="sv-SE" smtClean="0"/>
              <a:t>2021-08-13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7774AB-FCF0-4D1B-8EE5-6BEDA43C83B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853956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upp 48"/>
          <p:cNvGrpSpPr/>
          <p:nvPr/>
        </p:nvGrpSpPr>
        <p:grpSpPr>
          <a:xfrm>
            <a:off x="611560" y="643109"/>
            <a:ext cx="3662883" cy="6176435"/>
            <a:chOff x="3041563" y="278651"/>
            <a:chExt cx="3662883" cy="6176435"/>
          </a:xfrm>
        </p:grpSpPr>
        <p:pic>
          <p:nvPicPr>
            <p:cNvPr id="2056" name="Picture 8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1311"/>
            <a:stretch/>
          </p:blipFill>
          <p:spPr bwMode="auto">
            <a:xfrm>
              <a:off x="3943759" y="5759885"/>
              <a:ext cx="2663233" cy="69520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" name="textruta 2"/>
            <p:cNvSpPr txBox="1"/>
            <p:nvPr/>
          </p:nvSpPr>
          <p:spPr>
            <a:xfrm>
              <a:off x="3343933" y="278651"/>
              <a:ext cx="2178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osition	              Human  </a:t>
              </a:r>
              <a:endParaRPr lang="sv-S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" name="Grupp 3"/>
            <p:cNvGrpSpPr/>
            <p:nvPr/>
          </p:nvGrpSpPr>
          <p:grpSpPr>
            <a:xfrm>
              <a:off x="3044614" y="582918"/>
              <a:ext cx="893960" cy="709938"/>
              <a:chOff x="734248" y="668244"/>
              <a:chExt cx="893960" cy="709938"/>
            </a:xfrm>
          </p:grpSpPr>
          <p:sp>
            <p:nvSpPr>
              <p:cNvPr id="5" name="textruta 4"/>
              <p:cNvSpPr txBox="1"/>
              <p:nvPr/>
            </p:nvSpPr>
            <p:spPr>
              <a:xfrm>
                <a:off x="1187068" y="672106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80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textruta 5"/>
              <p:cNvSpPr txBox="1"/>
              <p:nvPr/>
            </p:nvSpPr>
            <p:spPr>
              <a:xfrm>
                <a:off x="740054" y="668244"/>
                <a:ext cx="5549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ruta 6"/>
              <p:cNvSpPr txBox="1"/>
              <p:nvPr/>
            </p:nvSpPr>
            <p:spPr>
              <a:xfrm>
                <a:off x="734248" y="1097888"/>
                <a:ext cx="55816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ruta 7"/>
              <p:cNvSpPr txBox="1"/>
              <p:nvPr/>
            </p:nvSpPr>
            <p:spPr>
              <a:xfrm>
                <a:off x="1207900" y="1116572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70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" name="Grupp 9"/>
            <p:cNvGrpSpPr/>
            <p:nvPr/>
          </p:nvGrpSpPr>
          <p:grpSpPr>
            <a:xfrm>
              <a:off x="3044614" y="1424669"/>
              <a:ext cx="890598" cy="735262"/>
              <a:chOff x="734248" y="1397021"/>
              <a:chExt cx="890598" cy="735262"/>
            </a:xfrm>
          </p:grpSpPr>
          <p:sp>
            <p:nvSpPr>
              <p:cNvPr id="12" name="textruta 11"/>
              <p:cNvSpPr txBox="1"/>
              <p:nvPr/>
            </p:nvSpPr>
            <p:spPr>
              <a:xfrm>
                <a:off x="740054" y="1397021"/>
                <a:ext cx="5549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ruta 12"/>
              <p:cNvSpPr txBox="1"/>
              <p:nvPr/>
            </p:nvSpPr>
            <p:spPr>
              <a:xfrm>
                <a:off x="734248" y="1870673"/>
                <a:ext cx="55816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ruta 13"/>
              <p:cNvSpPr txBox="1"/>
              <p:nvPr/>
            </p:nvSpPr>
            <p:spPr>
              <a:xfrm>
                <a:off x="1186949" y="1411435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80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ruta 14"/>
              <p:cNvSpPr txBox="1"/>
              <p:nvPr/>
            </p:nvSpPr>
            <p:spPr>
              <a:xfrm>
                <a:off x="1204538" y="1870673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65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6" name="Grupp 15"/>
            <p:cNvGrpSpPr/>
            <p:nvPr/>
          </p:nvGrpSpPr>
          <p:grpSpPr>
            <a:xfrm>
              <a:off x="3047820" y="2339247"/>
              <a:ext cx="899427" cy="712602"/>
              <a:chOff x="737454" y="2246080"/>
              <a:chExt cx="899427" cy="712602"/>
            </a:xfrm>
          </p:grpSpPr>
          <p:sp>
            <p:nvSpPr>
              <p:cNvPr id="18" name="textruta 17"/>
              <p:cNvSpPr txBox="1"/>
              <p:nvPr/>
            </p:nvSpPr>
            <p:spPr>
              <a:xfrm>
                <a:off x="737454" y="2250421"/>
                <a:ext cx="5549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ruta 18"/>
              <p:cNvSpPr txBox="1"/>
              <p:nvPr/>
            </p:nvSpPr>
            <p:spPr>
              <a:xfrm>
                <a:off x="746963" y="2697072"/>
                <a:ext cx="54694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γ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ruta 19"/>
              <p:cNvSpPr txBox="1"/>
              <p:nvPr/>
            </p:nvSpPr>
            <p:spPr>
              <a:xfrm>
                <a:off x="1216573" y="2246080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80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ruta 20"/>
              <p:cNvSpPr txBox="1"/>
              <p:nvPr/>
            </p:nvSpPr>
            <p:spPr>
              <a:xfrm>
                <a:off x="1202630" y="2687547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67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" name="Grupp 21"/>
            <p:cNvGrpSpPr/>
            <p:nvPr/>
          </p:nvGrpSpPr>
          <p:grpSpPr>
            <a:xfrm>
              <a:off x="3041563" y="3184401"/>
              <a:ext cx="894028" cy="708169"/>
              <a:chOff x="766814" y="2964148"/>
              <a:chExt cx="894028" cy="708169"/>
            </a:xfrm>
          </p:grpSpPr>
          <p:sp>
            <p:nvSpPr>
              <p:cNvPr id="24" name="textruta 23"/>
              <p:cNvSpPr txBox="1"/>
              <p:nvPr/>
            </p:nvSpPr>
            <p:spPr>
              <a:xfrm>
                <a:off x="766814" y="2965688"/>
                <a:ext cx="5549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textruta 24"/>
              <p:cNvSpPr txBox="1"/>
              <p:nvPr/>
            </p:nvSpPr>
            <p:spPr>
              <a:xfrm>
                <a:off x="782580" y="3409906"/>
                <a:ext cx="53893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ε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textruta 25"/>
              <p:cNvSpPr txBox="1"/>
              <p:nvPr/>
            </p:nvSpPr>
            <p:spPr>
              <a:xfrm>
                <a:off x="1232336" y="2964148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80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textruta 26"/>
              <p:cNvSpPr txBox="1"/>
              <p:nvPr/>
            </p:nvSpPr>
            <p:spPr>
              <a:xfrm>
                <a:off x="1240534" y="3410707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78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8" name="Grupp 27"/>
            <p:cNvGrpSpPr/>
            <p:nvPr/>
          </p:nvGrpSpPr>
          <p:grpSpPr>
            <a:xfrm>
              <a:off x="3057329" y="4058022"/>
              <a:ext cx="873559" cy="720285"/>
              <a:chOff x="781857" y="4266720"/>
              <a:chExt cx="873559" cy="720285"/>
            </a:xfrm>
          </p:grpSpPr>
          <p:sp>
            <p:nvSpPr>
              <p:cNvPr id="30" name="textruta 29"/>
              <p:cNvSpPr txBox="1"/>
              <p:nvPr/>
            </p:nvSpPr>
            <p:spPr>
              <a:xfrm>
                <a:off x="781857" y="4281177"/>
                <a:ext cx="5549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ruta 30"/>
              <p:cNvSpPr txBox="1"/>
              <p:nvPr/>
            </p:nvSpPr>
            <p:spPr>
              <a:xfrm>
                <a:off x="781857" y="4725395"/>
                <a:ext cx="53893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ζ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ruta 31"/>
              <p:cNvSpPr txBox="1"/>
              <p:nvPr/>
            </p:nvSpPr>
            <p:spPr>
              <a:xfrm>
                <a:off x="1222881" y="4266720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80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ruta 32"/>
              <p:cNvSpPr txBox="1"/>
              <p:nvPr/>
            </p:nvSpPr>
            <p:spPr>
              <a:xfrm>
                <a:off x="1235108" y="4716671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67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" name="Grupp 33"/>
            <p:cNvGrpSpPr/>
            <p:nvPr/>
          </p:nvGrpSpPr>
          <p:grpSpPr>
            <a:xfrm>
              <a:off x="3058696" y="4926310"/>
              <a:ext cx="870719" cy="698090"/>
              <a:chOff x="748330" y="4642634"/>
              <a:chExt cx="870719" cy="698090"/>
            </a:xfrm>
          </p:grpSpPr>
          <p:sp>
            <p:nvSpPr>
              <p:cNvPr id="36" name="textruta 35"/>
              <p:cNvSpPr txBox="1"/>
              <p:nvPr/>
            </p:nvSpPr>
            <p:spPr>
              <a:xfrm>
                <a:off x="753317" y="4643620"/>
                <a:ext cx="5549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ruta 36"/>
              <p:cNvSpPr txBox="1"/>
              <p:nvPr/>
            </p:nvSpPr>
            <p:spPr>
              <a:xfrm>
                <a:off x="748330" y="5079114"/>
                <a:ext cx="5549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η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textruta 37"/>
              <p:cNvSpPr txBox="1"/>
              <p:nvPr/>
            </p:nvSpPr>
            <p:spPr>
              <a:xfrm>
                <a:off x="1198741" y="4642634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80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ruta 38"/>
              <p:cNvSpPr txBox="1"/>
              <p:nvPr/>
            </p:nvSpPr>
            <p:spPr>
              <a:xfrm>
                <a:off x="1195202" y="5079114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65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1" name="textruta 40"/>
            <p:cNvSpPr txBox="1"/>
            <p:nvPr/>
          </p:nvSpPr>
          <p:spPr>
            <a:xfrm>
              <a:off x="3063683" y="5770864"/>
              <a:ext cx="5549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CT</a:t>
              </a:r>
              <a:r>
                <a:rPr lang="el-G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endParaRPr lang="sv-S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ruta 41"/>
            <p:cNvSpPr txBox="1"/>
            <p:nvPr/>
          </p:nvSpPr>
          <p:spPr>
            <a:xfrm>
              <a:off x="3062255" y="6186507"/>
              <a:ext cx="5549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CT</a:t>
              </a:r>
              <a:r>
                <a:rPr lang="el-G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η</a:t>
              </a:r>
              <a:endParaRPr lang="sv-S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ruta 42"/>
            <p:cNvSpPr txBox="1"/>
            <p:nvPr/>
          </p:nvSpPr>
          <p:spPr>
            <a:xfrm>
              <a:off x="3503620" y="5761831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80</a:t>
              </a:r>
              <a:endParaRPr lang="sv-S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ruta 43"/>
            <p:cNvSpPr txBox="1"/>
            <p:nvPr/>
          </p:nvSpPr>
          <p:spPr>
            <a:xfrm>
              <a:off x="3519009" y="6187308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7</a:t>
              </a:r>
              <a:endParaRPr lang="sv-S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0" name="Picture 2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1512"/>
            <a:stretch/>
          </p:blipFill>
          <p:spPr bwMode="auto">
            <a:xfrm>
              <a:off x="3950193" y="580683"/>
              <a:ext cx="2638031" cy="69348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2" name="Rektangel 51"/>
            <p:cNvSpPr/>
            <p:nvPr/>
          </p:nvSpPr>
          <p:spPr>
            <a:xfrm>
              <a:off x="5179797" y="567766"/>
              <a:ext cx="108202" cy="695818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pic>
          <p:nvPicPr>
            <p:cNvPr id="2050" name="Picture 2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0344"/>
            <a:stretch/>
          </p:blipFill>
          <p:spPr bwMode="auto">
            <a:xfrm>
              <a:off x="3940668" y="1444229"/>
              <a:ext cx="2763778" cy="69792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4" name="Rektangel 53"/>
            <p:cNvSpPr/>
            <p:nvPr/>
          </p:nvSpPr>
          <p:spPr>
            <a:xfrm>
              <a:off x="5183198" y="1437250"/>
              <a:ext cx="108202" cy="695818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pic>
          <p:nvPicPr>
            <p:cNvPr id="2051" name="Picture 3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1311"/>
            <a:stretch/>
          </p:blipFill>
          <p:spPr bwMode="auto">
            <a:xfrm>
              <a:off x="3938574" y="2325517"/>
              <a:ext cx="2694797" cy="7034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6" name="Rektangel 55"/>
            <p:cNvSpPr/>
            <p:nvPr/>
          </p:nvSpPr>
          <p:spPr>
            <a:xfrm>
              <a:off x="5181972" y="2325517"/>
              <a:ext cx="108202" cy="695818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pic>
          <p:nvPicPr>
            <p:cNvPr id="2052" name="Picture 4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1476"/>
            <a:stretch/>
          </p:blipFill>
          <p:spPr bwMode="auto">
            <a:xfrm>
              <a:off x="3939317" y="3184515"/>
              <a:ext cx="2648907" cy="69546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8" name="Rektangel 57"/>
            <p:cNvSpPr/>
            <p:nvPr/>
          </p:nvSpPr>
          <p:spPr>
            <a:xfrm>
              <a:off x="5180862" y="3165230"/>
              <a:ext cx="108202" cy="695818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pic>
          <p:nvPicPr>
            <p:cNvPr id="2053" name="Picture 5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1145"/>
            <a:stretch/>
          </p:blipFill>
          <p:spPr bwMode="auto">
            <a:xfrm>
              <a:off x="3950137" y="4058271"/>
              <a:ext cx="2683233" cy="6964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0" name="Rektangel 59"/>
            <p:cNvSpPr/>
            <p:nvPr/>
          </p:nvSpPr>
          <p:spPr>
            <a:xfrm>
              <a:off x="5181972" y="4043330"/>
              <a:ext cx="108202" cy="695818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pic>
          <p:nvPicPr>
            <p:cNvPr id="2054" name="Picture 6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1476"/>
            <a:stretch/>
          </p:blipFill>
          <p:spPr bwMode="auto">
            <a:xfrm>
              <a:off x="3947247" y="4923384"/>
              <a:ext cx="2628484" cy="6901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2" name="Rektangel 61"/>
            <p:cNvSpPr/>
            <p:nvPr/>
          </p:nvSpPr>
          <p:spPr>
            <a:xfrm>
              <a:off x="5172327" y="4891548"/>
              <a:ext cx="108202" cy="695818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64" name="Rektangel 63"/>
            <p:cNvSpPr/>
            <p:nvPr/>
          </p:nvSpPr>
          <p:spPr>
            <a:xfrm>
              <a:off x="5180862" y="5744222"/>
              <a:ext cx="108202" cy="695818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</p:grpSp>
      <p:grpSp>
        <p:nvGrpSpPr>
          <p:cNvPr id="57" name="Grupp 56"/>
          <p:cNvGrpSpPr/>
          <p:nvPr/>
        </p:nvGrpSpPr>
        <p:grpSpPr>
          <a:xfrm>
            <a:off x="4716016" y="620688"/>
            <a:ext cx="2449112" cy="6170267"/>
            <a:chOff x="3041563" y="278651"/>
            <a:chExt cx="2449112" cy="6170267"/>
          </a:xfrm>
        </p:grpSpPr>
        <p:sp>
          <p:nvSpPr>
            <p:cNvPr id="61" name="textruta 60"/>
            <p:cNvSpPr txBox="1"/>
            <p:nvPr/>
          </p:nvSpPr>
          <p:spPr>
            <a:xfrm>
              <a:off x="3343933" y="278651"/>
              <a:ext cx="21467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osition	              Mouse  </a:t>
              </a:r>
              <a:endParaRPr lang="sv-S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3" name="Grupp 62"/>
            <p:cNvGrpSpPr/>
            <p:nvPr/>
          </p:nvGrpSpPr>
          <p:grpSpPr>
            <a:xfrm>
              <a:off x="3044614" y="582918"/>
              <a:ext cx="893960" cy="709938"/>
              <a:chOff x="734248" y="668244"/>
              <a:chExt cx="893960" cy="709938"/>
            </a:xfrm>
          </p:grpSpPr>
          <p:sp>
            <p:nvSpPr>
              <p:cNvPr id="107" name="textruta 106"/>
              <p:cNvSpPr txBox="1"/>
              <p:nvPr/>
            </p:nvSpPr>
            <p:spPr>
              <a:xfrm>
                <a:off x="1187068" y="672106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80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textruta 107"/>
              <p:cNvSpPr txBox="1"/>
              <p:nvPr/>
            </p:nvSpPr>
            <p:spPr>
              <a:xfrm>
                <a:off x="740054" y="668244"/>
                <a:ext cx="5549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textruta 108"/>
              <p:cNvSpPr txBox="1"/>
              <p:nvPr/>
            </p:nvSpPr>
            <p:spPr>
              <a:xfrm>
                <a:off x="734248" y="1097888"/>
                <a:ext cx="55816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textruta 109"/>
              <p:cNvSpPr txBox="1"/>
              <p:nvPr/>
            </p:nvSpPr>
            <p:spPr>
              <a:xfrm>
                <a:off x="1207900" y="1116572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70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5" name="Grupp 64"/>
            <p:cNvGrpSpPr/>
            <p:nvPr/>
          </p:nvGrpSpPr>
          <p:grpSpPr>
            <a:xfrm>
              <a:off x="3044614" y="1424669"/>
              <a:ext cx="890598" cy="765406"/>
              <a:chOff x="734248" y="1397021"/>
              <a:chExt cx="890598" cy="765406"/>
            </a:xfrm>
          </p:grpSpPr>
          <p:sp>
            <p:nvSpPr>
              <p:cNvPr id="103" name="textruta 102"/>
              <p:cNvSpPr txBox="1"/>
              <p:nvPr/>
            </p:nvSpPr>
            <p:spPr>
              <a:xfrm>
                <a:off x="740054" y="1397021"/>
                <a:ext cx="5549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textruta 103"/>
              <p:cNvSpPr txBox="1"/>
              <p:nvPr/>
            </p:nvSpPr>
            <p:spPr>
              <a:xfrm>
                <a:off x="734248" y="1900817"/>
                <a:ext cx="55816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textruta 104"/>
              <p:cNvSpPr txBox="1"/>
              <p:nvPr/>
            </p:nvSpPr>
            <p:spPr>
              <a:xfrm>
                <a:off x="1186949" y="1411435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80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textruta 105"/>
              <p:cNvSpPr txBox="1"/>
              <p:nvPr/>
            </p:nvSpPr>
            <p:spPr>
              <a:xfrm>
                <a:off x="1204538" y="1893417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65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6" name="Grupp 65"/>
            <p:cNvGrpSpPr/>
            <p:nvPr/>
          </p:nvGrpSpPr>
          <p:grpSpPr>
            <a:xfrm>
              <a:off x="3047820" y="2339247"/>
              <a:ext cx="899427" cy="712602"/>
              <a:chOff x="737454" y="2246080"/>
              <a:chExt cx="899427" cy="712602"/>
            </a:xfrm>
          </p:grpSpPr>
          <p:sp>
            <p:nvSpPr>
              <p:cNvPr id="99" name="textruta 98"/>
              <p:cNvSpPr txBox="1"/>
              <p:nvPr/>
            </p:nvSpPr>
            <p:spPr>
              <a:xfrm>
                <a:off x="737454" y="2250421"/>
                <a:ext cx="5549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textruta 99"/>
              <p:cNvSpPr txBox="1"/>
              <p:nvPr/>
            </p:nvSpPr>
            <p:spPr>
              <a:xfrm>
                <a:off x="746963" y="2697072"/>
                <a:ext cx="54694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γ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textruta 100"/>
              <p:cNvSpPr txBox="1"/>
              <p:nvPr/>
            </p:nvSpPr>
            <p:spPr>
              <a:xfrm>
                <a:off x="1216573" y="2246080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80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textruta 101"/>
              <p:cNvSpPr txBox="1"/>
              <p:nvPr/>
            </p:nvSpPr>
            <p:spPr>
              <a:xfrm>
                <a:off x="1202630" y="2687547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67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7" name="Grupp 66"/>
            <p:cNvGrpSpPr/>
            <p:nvPr/>
          </p:nvGrpSpPr>
          <p:grpSpPr>
            <a:xfrm>
              <a:off x="3041563" y="3184401"/>
              <a:ext cx="894028" cy="708169"/>
              <a:chOff x="766814" y="2964148"/>
              <a:chExt cx="894028" cy="708169"/>
            </a:xfrm>
          </p:grpSpPr>
          <p:sp>
            <p:nvSpPr>
              <p:cNvPr id="95" name="textruta 94"/>
              <p:cNvSpPr txBox="1"/>
              <p:nvPr/>
            </p:nvSpPr>
            <p:spPr>
              <a:xfrm>
                <a:off x="766814" y="2965688"/>
                <a:ext cx="5549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textruta 95"/>
              <p:cNvSpPr txBox="1"/>
              <p:nvPr/>
            </p:nvSpPr>
            <p:spPr>
              <a:xfrm>
                <a:off x="782580" y="3409906"/>
                <a:ext cx="53893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ε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textruta 96"/>
              <p:cNvSpPr txBox="1"/>
              <p:nvPr/>
            </p:nvSpPr>
            <p:spPr>
              <a:xfrm>
                <a:off x="1232336" y="2964148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80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textruta 97"/>
              <p:cNvSpPr txBox="1"/>
              <p:nvPr/>
            </p:nvSpPr>
            <p:spPr>
              <a:xfrm>
                <a:off x="1240534" y="3410707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78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8" name="Grupp 67"/>
            <p:cNvGrpSpPr/>
            <p:nvPr/>
          </p:nvGrpSpPr>
          <p:grpSpPr>
            <a:xfrm>
              <a:off x="3057329" y="4058022"/>
              <a:ext cx="873559" cy="720285"/>
              <a:chOff x="781857" y="4266720"/>
              <a:chExt cx="873559" cy="720285"/>
            </a:xfrm>
          </p:grpSpPr>
          <p:sp>
            <p:nvSpPr>
              <p:cNvPr id="91" name="textruta 90"/>
              <p:cNvSpPr txBox="1"/>
              <p:nvPr/>
            </p:nvSpPr>
            <p:spPr>
              <a:xfrm>
                <a:off x="781857" y="4281177"/>
                <a:ext cx="5549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textruta 91"/>
              <p:cNvSpPr txBox="1"/>
              <p:nvPr/>
            </p:nvSpPr>
            <p:spPr>
              <a:xfrm>
                <a:off x="781857" y="4725395"/>
                <a:ext cx="53893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ζ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textruta 92"/>
              <p:cNvSpPr txBox="1"/>
              <p:nvPr/>
            </p:nvSpPr>
            <p:spPr>
              <a:xfrm>
                <a:off x="1222881" y="4266720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80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textruta 93"/>
              <p:cNvSpPr txBox="1"/>
              <p:nvPr/>
            </p:nvSpPr>
            <p:spPr>
              <a:xfrm>
                <a:off x="1235108" y="4716671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67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9" name="Grupp 68"/>
            <p:cNvGrpSpPr/>
            <p:nvPr/>
          </p:nvGrpSpPr>
          <p:grpSpPr>
            <a:xfrm>
              <a:off x="3058696" y="4898841"/>
              <a:ext cx="870719" cy="746825"/>
              <a:chOff x="748330" y="4615165"/>
              <a:chExt cx="870719" cy="746825"/>
            </a:xfrm>
          </p:grpSpPr>
          <p:sp>
            <p:nvSpPr>
              <p:cNvPr id="87" name="textruta 86"/>
              <p:cNvSpPr txBox="1"/>
              <p:nvPr/>
            </p:nvSpPr>
            <p:spPr>
              <a:xfrm>
                <a:off x="753317" y="4616151"/>
                <a:ext cx="554960" cy="3165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textruta 87"/>
              <p:cNvSpPr txBox="1"/>
              <p:nvPr/>
            </p:nvSpPr>
            <p:spPr>
              <a:xfrm>
                <a:off x="748330" y="5100380"/>
                <a:ext cx="5549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CT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η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textruta 88"/>
              <p:cNvSpPr txBox="1"/>
              <p:nvPr/>
            </p:nvSpPr>
            <p:spPr>
              <a:xfrm>
                <a:off x="1198741" y="4615165"/>
                <a:ext cx="420308" cy="3165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80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textruta 89"/>
              <p:cNvSpPr txBox="1"/>
              <p:nvPr/>
            </p:nvSpPr>
            <p:spPr>
              <a:xfrm>
                <a:off x="1195202" y="5100380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65</a:t>
                </a:r>
                <a:endParaRPr lang="sv-SE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0" name="textruta 69"/>
            <p:cNvSpPr txBox="1"/>
            <p:nvPr/>
          </p:nvSpPr>
          <p:spPr>
            <a:xfrm>
              <a:off x="3063683" y="5738965"/>
              <a:ext cx="5549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CT</a:t>
              </a:r>
              <a:r>
                <a:rPr lang="el-G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endParaRPr lang="sv-S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ruta 70"/>
            <p:cNvSpPr txBox="1"/>
            <p:nvPr/>
          </p:nvSpPr>
          <p:spPr>
            <a:xfrm>
              <a:off x="3062255" y="6186507"/>
              <a:ext cx="5549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CT</a:t>
              </a:r>
              <a:r>
                <a:rPr lang="el-G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η</a:t>
              </a:r>
              <a:endParaRPr lang="sv-S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ruta 71"/>
            <p:cNvSpPr txBox="1"/>
            <p:nvPr/>
          </p:nvSpPr>
          <p:spPr>
            <a:xfrm>
              <a:off x="3503620" y="5729932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80</a:t>
              </a:r>
              <a:endParaRPr lang="sv-S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ruta 72"/>
            <p:cNvSpPr txBox="1"/>
            <p:nvPr/>
          </p:nvSpPr>
          <p:spPr>
            <a:xfrm>
              <a:off x="3519009" y="6187308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7</a:t>
              </a:r>
              <a:endParaRPr lang="sv-S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Rektangel 74"/>
            <p:cNvSpPr/>
            <p:nvPr/>
          </p:nvSpPr>
          <p:spPr>
            <a:xfrm>
              <a:off x="5179797" y="567766"/>
              <a:ext cx="108202" cy="695818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77" name="Rektangel 76"/>
            <p:cNvSpPr/>
            <p:nvPr/>
          </p:nvSpPr>
          <p:spPr>
            <a:xfrm>
              <a:off x="5183198" y="1457346"/>
              <a:ext cx="108202" cy="695818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79" name="Rektangel 78"/>
            <p:cNvSpPr/>
            <p:nvPr/>
          </p:nvSpPr>
          <p:spPr>
            <a:xfrm>
              <a:off x="5181972" y="2325517"/>
              <a:ext cx="108202" cy="695818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81" name="Rektangel 80"/>
            <p:cNvSpPr/>
            <p:nvPr/>
          </p:nvSpPr>
          <p:spPr>
            <a:xfrm>
              <a:off x="5180862" y="3165230"/>
              <a:ext cx="108202" cy="695818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83" name="Rektangel 82"/>
            <p:cNvSpPr/>
            <p:nvPr/>
          </p:nvSpPr>
          <p:spPr>
            <a:xfrm>
              <a:off x="5181972" y="4043330"/>
              <a:ext cx="108202" cy="695818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85" name="Rektangel 84"/>
            <p:cNvSpPr/>
            <p:nvPr/>
          </p:nvSpPr>
          <p:spPr>
            <a:xfrm>
              <a:off x="5181972" y="4891548"/>
              <a:ext cx="108202" cy="695818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86" name="Rektangel 85"/>
            <p:cNvSpPr/>
            <p:nvPr/>
          </p:nvSpPr>
          <p:spPr>
            <a:xfrm>
              <a:off x="5180862" y="5744222"/>
              <a:ext cx="108202" cy="695818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</p:grpSp>
      <p:sp>
        <p:nvSpPr>
          <p:cNvPr id="2" name="textruta 1"/>
          <p:cNvSpPr txBox="1"/>
          <p:nvPr/>
        </p:nvSpPr>
        <p:spPr>
          <a:xfrm>
            <a:off x="251520" y="620688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1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ruta 110"/>
          <p:cNvSpPr txBox="1"/>
          <p:nvPr/>
        </p:nvSpPr>
        <p:spPr>
          <a:xfrm>
            <a:off x="4453905" y="620688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1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1347" b="-8606"/>
          <a:stretch/>
        </p:blipFill>
        <p:spPr bwMode="auto">
          <a:xfrm>
            <a:off x="5551363" y="933731"/>
            <a:ext cx="2802945" cy="7765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1262"/>
          <a:stretch/>
        </p:blipFill>
        <p:spPr bwMode="auto">
          <a:xfrm>
            <a:off x="5561411" y="1796850"/>
            <a:ext cx="2802945" cy="7304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1610"/>
          <a:stretch/>
        </p:blipFill>
        <p:spPr bwMode="auto">
          <a:xfrm>
            <a:off x="5561932" y="2680230"/>
            <a:ext cx="2762232" cy="7057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1959"/>
          <a:stretch/>
        </p:blipFill>
        <p:spPr bwMode="auto">
          <a:xfrm>
            <a:off x="5561411" y="3531775"/>
            <a:ext cx="2715629" cy="7091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1784"/>
          <a:stretch/>
        </p:blipFill>
        <p:spPr bwMode="auto">
          <a:xfrm>
            <a:off x="5571459" y="4401822"/>
            <a:ext cx="2725677" cy="7126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9" name="Picture 7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1959"/>
          <a:stretch/>
        </p:blipFill>
        <p:spPr bwMode="auto">
          <a:xfrm>
            <a:off x="5571460" y="5257698"/>
            <a:ext cx="2705580" cy="7128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0" name="Picture 8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1784"/>
          <a:stretch/>
        </p:blipFill>
        <p:spPr bwMode="auto">
          <a:xfrm>
            <a:off x="5581508" y="6070323"/>
            <a:ext cx="2705580" cy="731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555293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8</TotalTime>
  <Words>88</Words>
  <Application>Microsoft Office PowerPoint</Application>
  <PresentationFormat>Bildspel på skärmen (4:3)</PresentationFormat>
  <Paragraphs>6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2" baseType="lpstr">
      <vt:lpstr>Office-tema</vt:lpstr>
      <vt:lpstr>PowerPoint-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Josefine</dc:creator>
  <cp:lastModifiedBy>Josefine</cp:lastModifiedBy>
  <cp:revision>10</cp:revision>
  <dcterms:created xsi:type="dcterms:W3CDTF">2021-08-10T09:45:29Z</dcterms:created>
  <dcterms:modified xsi:type="dcterms:W3CDTF">2021-08-13T14:29:06Z</dcterms:modified>
</cp:coreProperties>
</file>